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E26F24-EF05-E07C-9691-063D44E207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942999-7B48-468C-AD08-23AA25403B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2A2318-E760-D91F-76E0-B585DFC67C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6939C6C-B196-5F37-A324-434EDA1EA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828004-D9E2-862B-F341-1F7581B22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5775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1FFC45-7B82-A86A-AFB7-F893A33179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8499F4-4E45-C573-C091-809D6AD33A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0B3123-EB23-C542-CDA3-428C3BC0F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B73524A-2825-289C-EFD8-4DCB7D1D5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54DFB4-15C6-A175-C7F0-B7A868062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809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10BFF51-4CA0-FD0E-18CC-F20638E331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B91B145-7DBD-DF07-7706-152109FD60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BC9008-1088-794B-EF98-2D298DB85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C720D3-EDB5-ECFE-7088-674FCC60F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71295B-22FD-6009-8FC8-B326E7C3C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5990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6F937E-4420-43A7-5FDA-294B82D8DA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700FDC2-E889-E230-B58E-FACA8C8041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65FB61-2BCA-4A90-6AA9-54D759B92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556CBF-EC4A-24EB-93A6-388A09ABC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F4D8B4-02C5-A1D7-E51E-51948EF0C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5639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4359C0-21F6-0D23-6A34-465B0BB727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C7901D6-115B-A584-AC9C-7B3FB96F5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B89758-7ACB-DE50-3EFA-235401D8A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E16AE2-A425-869B-28BA-839E1957A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CB88DC6-8005-89DF-1F7D-F9A164B5E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489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961E49-C61C-2889-D876-27D8CCB6C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0F5D0C2-15F6-0F86-31F3-21A058D48C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9F9995-01B8-2131-8C6C-1F6F9BDF1F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41548D-CA8B-BEAC-E74E-37622A2AA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809FE4D-34C2-CFA1-9318-12BB86AF3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5DA65B0-F484-544C-2BFE-8BAE54314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647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5CC005-ABA0-972C-732D-3F33326B7B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29F7A0-9679-5CAE-ED38-4F7C0F33E0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C6BA1AE-CE4A-A25E-0CAC-9B05516B63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3B509C2-97FB-5961-D09C-39228DDE62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AA92473-89CC-25C3-7AA0-1F05453513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74601AF-6101-B6DC-E317-1D691D3E6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DF1B1D3-707F-61C4-640D-931504F42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F1F6C0E-6F30-5D2E-B72B-836BEA3F7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2653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86DB8B-83ED-8528-EE31-483EEA3964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1538E2D-5AB9-5E6A-FC52-BEA0D705F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4FEA110-F6AF-5A47-8200-F2950084E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3C96447-5857-5DA7-12D6-D066DDED1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400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C0DC889-4B94-6AA1-CD7C-324A48D955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A9A0530-2D30-AEAF-E5C7-BBD7721874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CC483EF-EFD3-12C9-D8AB-691943AAA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799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13AA74-B4AA-A591-7BE3-A6A5BF000D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55653C2-5F8F-86FB-6AB4-67519DBAF53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68B256F-7EF4-A504-7BA9-372E99EEBC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2B4CEA8-4963-AD57-87BF-0D4B997B2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85349D-7590-EDFD-A21E-3E56D7DBBE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97376E2-1299-A560-0C46-29F950770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6951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FE0661-F61D-5D4F-61D7-4E3C7E7D3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37EF16A-4504-387E-6598-7AF8C0746E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3D9978B-A432-F2AB-F7CE-FF3F55A353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9A4C84-9FEF-C40C-61E7-1F708B6BB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651E66-7A52-C6D1-B390-3FC170E44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C203CE1-5772-E745-B065-DD024A149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228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C8DA4DE-DABF-4DCB-BC10-362312547B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FCCFA7-7A48-2E54-CADA-9D332474F5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91D053-DE6F-F8FC-3F8F-B3858C69DB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CC9F0C-E27A-4CA2-A0AD-7E43D3F095D2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BC7241E-3E0B-BE06-B8EF-C8D5E70465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2E860A5-00DE-8DA6-35E3-1E1071707F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9A885-FB41-4459-A8DE-C1D5D39902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4126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4">
            <a:extLst>
              <a:ext uri="{FF2B5EF4-FFF2-40B4-BE49-F238E27FC236}">
                <a16:creationId xmlns:a16="http://schemas.microsoft.com/office/drawing/2014/main" id="{AF37194C-0B51-E9BD-E281-FFC170FFF089}"/>
              </a:ext>
            </a:extLst>
          </p:cNvPr>
          <p:cNvGrpSpPr/>
          <p:nvPr/>
        </p:nvGrpSpPr>
        <p:grpSpPr>
          <a:xfrm>
            <a:off x="613825" y="906101"/>
            <a:ext cx="3395668" cy="1015663"/>
            <a:chOff x="4837466" y="3052405"/>
            <a:chExt cx="3395668" cy="1015663"/>
          </a:xfrm>
        </p:grpSpPr>
        <p:sp>
          <p:nvSpPr>
            <p:cNvPr id="3" name="文本框 29">
              <a:extLst>
                <a:ext uri="{FF2B5EF4-FFF2-40B4-BE49-F238E27FC236}">
                  <a16:creationId xmlns:a16="http://schemas.microsoft.com/office/drawing/2014/main" id="{1F3A74C2-8B93-11CD-B50D-862239ADABF5}"/>
                </a:ext>
              </a:extLst>
            </p:cNvPr>
            <p:cNvSpPr txBox="1"/>
            <p:nvPr/>
          </p:nvSpPr>
          <p:spPr>
            <a:xfrm>
              <a:off x="4837466" y="3052405"/>
              <a:ext cx="1389583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    </a:t>
              </a:r>
            </a:p>
            <a:p>
              <a:pPr algn="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-93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or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6-</a:t>
              </a:r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94-312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" name="文本框 29">
              <a:extLst>
                <a:ext uri="{FF2B5EF4-FFF2-40B4-BE49-F238E27FC236}">
                  <a16:creationId xmlns:a16="http://schemas.microsoft.com/office/drawing/2014/main" id="{CBA406EA-6DA5-9B7F-733B-00DE80607122}"/>
                </a:ext>
              </a:extLst>
            </p:cNvPr>
            <p:cNvSpPr txBox="1"/>
            <p:nvPr/>
          </p:nvSpPr>
          <p:spPr>
            <a:xfrm>
              <a:off x="6267011" y="3061724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-          -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-          +        +</a:t>
              </a:r>
            </a:p>
          </p:txBody>
        </p:sp>
      </p:grpSp>
      <p:grpSp>
        <p:nvGrpSpPr>
          <p:cNvPr id="5" name="Group 45">
            <a:extLst>
              <a:ext uri="{FF2B5EF4-FFF2-40B4-BE49-F238E27FC236}">
                <a16:creationId xmlns:a16="http://schemas.microsoft.com/office/drawing/2014/main" id="{4EE21F85-1000-2FF5-0690-C5C2D28A5AD5}"/>
              </a:ext>
            </a:extLst>
          </p:cNvPr>
          <p:cNvGrpSpPr/>
          <p:nvPr/>
        </p:nvGrpSpPr>
        <p:grpSpPr>
          <a:xfrm>
            <a:off x="547965" y="870060"/>
            <a:ext cx="4583506" cy="2315888"/>
            <a:chOff x="4947044" y="3358764"/>
            <a:chExt cx="4583506" cy="2315888"/>
          </a:xfrm>
        </p:grpSpPr>
        <p:sp>
          <p:nvSpPr>
            <p:cNvPr id="8" name="文本框 13">
              <a:extLst>
                <a:ext uri="{FF2B5EF4-FFF2-40B4-BE49-F238E27FC236}">
                  <a16:creationId xmlns:a16="http://schemas.microsoft.com/office/drawing/2014/main" id="{517E83DD-190A-7F02-C67B-9E6B36F74AAF}"/>
                </a:ext>
              </a:extLst>
            </p:cNvPr>
            <p:cNvSpPr txBox="1"/>
            <p:nvPr/>
          </p:nvSpPr>
          <p:spPr>
            <a:xfrm>
              <a:off x="4947044" y="5397653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endParaRPr lang="zh-CN" altLang="en-US" sz="1200" baseline="300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grpSp>
          <p:nvGrpSpPr>
            <p:cNvPr id="10" name="Group 138">
              <a:extLst>
                <a:ext uri="{FF2B5EF4-FFF2-40B4-BE49-F238E27FC236}">
                  <a16:creationId xmlns:a16="http://schemas.microsoft.com/office/drawing/2014/main" id="{96CE548B-C7C3-2A21-B573-0C3E0EF899F1}"/>
                </a:ext>
              </a:extLst>
            </p:cNvPr>
            <p:cNvGrpSpPr/>
            <p:nvPr/>
          </p:nvGrpSpPr>
          <p:grpSpPr>
            <a:xfrm>
              <a:off x="4972942" y="3889297"/>
              <a:ext cx="462671" cy="276999"/>
              <a:chOff x="-131243" y="946620"/>
              <a:chExt cx="462671" cy="276999"/>
            </a:xfrm>
          </p:grpSpPr>
          <p:cxnSp>
            <p:nvCxnSpPr>
              <p:cNvPr id="18" name="直接连接符 63">
                <a:extLst>
                  <a:ext uri="{FF2B5EF4-FFF2-40B4-BE49-F238E27FC236}">
                    <a16:creationId xmlns:a16="http://schemas.microsoft.com/office/drawing/2014/main" id="{36D5665F-301A-C8DA-2105-2B4C324F7D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1243" y="1201848"/>
                <a:ext cx="3657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文本框 49">
                <a:extLst>
                  <a:ext uri="{FF2B5EF4-FFF2-40B4-BE49-F238E27FC236}">
                    <a16:creationId xmlns:a16="http://schemas.microsoft.com/office/drawing/2014/main" id="{557E9339-F3CA-EA6C-EE35-8E6F72EAED50}"/>
                  </a:ext>
                </a:extLst>
              </p:cNvPr>
              <p:cNvSpPr txBox="1"/>
              <p:nvPr/>
            </p:nvSpPr>
            <p:spPr>
              <a:xfrm>
                <a:off x="-131243" y="946620"/>
                <a:ext cx="4626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Group 139">
              <a:extLst>
                <a:ext uri="{FF2B5EF4-FFF2-40B4-BE49-F238E27FC236}">
                  <a16:creationId xmlns:a16="http://schemas.microsoft.com/office/drawing/2014/main" id="{BC422039-B1B1-CA7E-8156-A5F7F515638A}"/>
                </a:ext>
              </a:extLst>
            </p:cNvPr>
            <p:cNvGrpSpPr/>
            <p:nvPr/>
          </p:nvGrpSpPr>
          <p:grpSpPr>
            <a:xfrm>
              <a:off x="8886861" y="3886730"/>
              <a:ext cx="643689" cy="276999"/>
              <a:chOff x="4785754" y="5215146"/>
              <a:chExt cx="643689" cy="276999"/>
            </a:xfrm>
          </p:grpSpPr>
          <p:cxnSp>
            <p:nvCxnSpPr>
              <p:cNvPr id="16" name="直接连接符 63">
                <a:extLst>
                  <a:ext uri="{FF2B5EF4-FFF2-40B4-BE49-F238E27FC236}">
                    <a16:creationId xmlns:a16="http://schemas.microsoft.com/office/drawing/2014/main" id="{610E915E-3864-E1B6-276C-FB6A5575C0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22042" y="547294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文本框 49">
                <a:extLst>
                  <a:ext uri="{FF2B5EF4-FFF2-40B4-BE49-F238E27FC236}">
                    <a16:creationId xmlns:a16="http://schemas.microsoft.com/office/drawing/2014/main" id="{82358BF6-191D-507F-1249-8CD2A76E2F42}"/>
                  </a:ext>
                </a:extLst>
              </p:cNvPr>
              <p:cNvSpPr txBox="1"/>
              <p:nvPr/>
            </p:nvSpPr>
            <p:spPr>
              <a:xfrm>
                <a:off x="4785754" y="5215146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5" name="直接连接符 63">
              <a:extLst>
                <a:ext uri="{FF2B5EF4-FFF2-40B4-BE49-F238E27FC236}">
                  <a16:creationId xmlns:a16="http://schemas.microsoft.com/office/drawing/2014/main" id="{469D9F9C-F6DB-EC4F-BCF7-CBAFB6C434D0}"/>
                </a:ext>
              </a:extLst>
            </p:cNvPr>
            <p:cNvCxnSpPr>
              <a:cxnSpLocks/>
            </p:cNvCxnSpPr>
            <p:nvPr/>
          </p:nvCxnSpPr>
          <p:spPr>
            <a:xfrm>
              <a:off x="6249305" y="3358764"/>
              <a:ext cx="1828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1" name="图片 20">
            <a:extLst>
              <a:ext uri="{FF2B5EF4-FFF2-40B4-BE49-F238E27FC236}">
                <a16:creationId xmlns:a16="http://schemas.microsoft.com/office/drawing/2014/main" id="{ABF023A5-A77C-C187-9ED2-9AB182DF7E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72" t="20405" r="34758" b="48091"/>
          <a:stretch/>
        </p:blipFill>
        <p:spPr>
          <a:xfrm>
            <a:off x="1010636" y="1704052"/>
            <a:ext cx="3301053" cy="2119365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25E5A071-77CB-348A-29C6-9DA475D0BAD0}"/>
              </a:ext>
            </a:extLst>
          </p:cNvPr>
          <p:cNvSpPr txBox="1"/>
          <p:nvPr/>
        </p:nvSpPr>
        <p:spPr>
          <a:xfrm>
            <a:off x="4359809" y="184934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B712C84-887B-6E57-6287-4064B08EC5AA}"/>
              </a:ext>
            </a:extLst>
          </p:cNvPr>
          <p:cNvSpPr txBox="1"/>
          <p:nvPr/>
        </p:nvSpPr>
        <p:spPr>
          <a:xfrm>
            <a:off x="4359809" y="227163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75D98A1F-9001-B77B-0299-D0753B09305A}"/>
              </a:ext>
            </a:extLst>
          </p:cNvPr>
          <p:cNvSpPr txBox="1"/>
          <p:nvPr/>
        </p:nvSpPr>
        <p:spPr>
          <a:xfrm>
            <a:off x="4359809" y="293797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44">
            <a:extLst>
              <a:ext uri="{FF2B5EF4-FFF2-40B4-BE49-F238E27FC236}">
                <a16:creationId xmlns:a16="http://schemas.microsoft.com/office/drawing/2014/main" id="{D149CBD3-02EA-D4FF-FEE4-7A056F44589E}"/>
              </a:ext>
            </a:extLst>
          </p:cNvPr>
          <p:cNvGrpSpPr/>
          <p:nvPr/>
        </p:nvGrpSpPr>
        <p:grpSpPr>
          <a:xfrm>
            <a:off x="6448568" y="906101"/>
            <a:ext cx="3395668" cy="1015663"/>
            <a:chOff x="4837466" y="3052405"/>
            <a:chExt cx="3395668" cy="1015663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2022054-84F5-809D-F9C5-55CD2FEE327D}"/>
                </a:ext>
              </a:extLst>
            </p:cNvPr>
            <p:cNvSpPr txBox="1"/>
            <p:nvPr/>
          </p:nvSpPr>
          <p:spPr>
            <a:xfrm>
              <a:off x="4837466" y="3052405"/>
              <a:ext cx="1389583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    </a:t>
              </a:r>
            </a:p>
            <a:p>
              <a:pPr algn="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-93 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or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6-</a:t>
              </a:r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r>
                <a:rPr lang="en-US" altLang="zh-CN" sz="1200" baseline="300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94-312</a:t>
              </a:r>
              <a:endParaRPr lang="en-US" altLang="zh-CN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1" name="文本框 29">
              <a:extLst>
                <a:ext uri="{FF2B5EF4-FFF2-40B4-BE49-F238E27FC236}">
                  <a16:creationId xmlns:a16="http://schemas.microsoft.com/office/drawing/2014/main" id="{77F0AA66-43B8-DC4B-9250-87337957CEAD}"/>
                </a:ext>
              </a:extLst>
            </p:cNvPr>
            <p:cNvSpPr txBox="1"/>
            <p:nvPr/>
          </p:nvSpPr>
          <p:spPr>
            <a:xfrm>
              <a:off x="6267011" y="3061724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-          -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-          +        +</a:t>
              </a:r>
            </a:p>
          </p:txBody>
        </p:sp>
      </p:grpSp>
      <p:grpSp>
        <p:nvGrpSpPr>
          <p:cNvPr id="32" name="Group 45">
            <a:extLst>
              <a:ext uri="{FF2B5EF4-FFF2-40B4-BE49-F238E27FC236}">
                <a16:creationId xmlns:a16="http://schemas.microsoft.com/office/drawing/2014/main" id="{773504C0-B145-FD5F-5557-3BEB318DFB20}"/>
              </a:ext>
            </a:extLst>
          </p:cNvPr>
          <p:cNvGrpSpPr/>
          <p:nvPr/>
        </p:nvGrpSpPr>
        <p:grpSpPr>
          <a:xfrm>
            <a:off x="6297972" y="870060"/>
            <a:ext cx="5655212" cy="2206415"/>
            <a:chOff x="4862308" y="3358764"/>
            <a:chExt cx="5655212" cy="2206415"/>
          </a:xfrm>
        </p:grpSpPr>
        <p:sp>
          <p:nvSpPr>
            <p:cNvPr id="33" name="文本框 13">
              <a:extLst>
                <a:ext uri="{FF2B5EF4-FFF2-40B4-BE49-F238E27FC236}">
                  <a16:creationId xmlns:a16="http://schemas.microsoft.com/office/drawing/2014/main" id="{E51D333A-90D4-59FD-98B3-B7DCD775D718}"/>
                </a:ext>
              </a:extLst>
            </p:cNvPr>
            <p:cNvSpPr txBox="1"/>
            <p:nvPr/>
          </p:nvSpPr>
          <p:spPr>
            <a:xfrm>
              <a:off x="4862308" y="5288180"/>
              <a:ext cx="5870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6</a:t>
              </a:r>
            </a:p>
          </p:txBody>
        </p:sp>
        <p:grpSp>
          <p:nvGrpSpPr>
            <p:cNvPr id="34" name="Group 138">
              <a:extLst>
                <a:ext uri="{FF2B5EF4-FFF2-40B4-BE49-F238E27FC236}">
                  <a16:creationId xmlns:a16="http://schemas.microsoft.com/office/drawing/2014/main" id="{1C114D6F-F5CD-83C0-BAB1-339EDA2353AF}"/>
                </a:ext>
              </a:extLst>
            </p:cNvPr>
            <p:cNvGrpSpPr/>
            <p:nvPr/>
          </p:nvGrpSpPr>
          <p:grpSpPr>
            <a:xfrm>
              <a:off x="4972942" y="3889297"/>
              <a:ext cx="462671" cy="276999"/>
              <a:chOff x="-131243" y="946620"/>
              <a:chExt cx="462671" cy="276999"/>
            </a:xfrm>
          </p:grpSpPr>
          <p:cxnSp>
            <p:nvCxnSpPr>
              <p:cNvPr id="39" name="直接连接符 63">
                <a:extLst>
                  <a:ext uri="{FF2B5EF4-FFF2-40B4-BE49-F238E27FC236}">
                    <a16:creationId xmlns:a16="http://schemas.microsoft.com/office/drawing/2014/main" id="{A0D9A1D6-63C1-7244-CECB-6D3CBACFE6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131243" y="1201848"/>
                <a:ext cx="3657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文本框 49">
                <a:extLst>
                  <a:ext uri="{FF2B5EF4-FFF2-40B4-BE49-F238E27FC236}">
                    <a16:creationId xmlns:a16="http://schemas.microsoft.com/office/drawing/2014/main" id="{25027613-0E1C-F226-E184-4BACE17F6BD8}"/>
                  </a:ext>
                </a:extLst>
              </p:cNvPr>
              <p:cNvSpPr txBox="1"/>
              <p:nvPr/>
            </p:nvSpPr>
            <p:spPr>
              <a:xfrm>
                <a:off x="-131243" y="946620"/>
                <a:ext cx="4626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" name="Group 139">
              <a:extLst>
                <a:ext uri="{FF2B5EF4-FFF2-40B4-BE49-F238E27FC236}">
                  <a16:creationId xmlns:a16="http://schemas.microsoft.com/office/drawing/2014/main" id="{16B44E6A-DED6-88D1-51C8-27CC8393F091}"/>
                </a:ext>
              </a:extLst>
            </p:cNvPr>
            <p:cNvGrpSpPr/>
            <p:nvPr/>
          </p:nvGrpSpPr>
          <p:grpSpPr>
            <a:xfrm>
              <a:off x="9873831" y="3886730"/>
              <a:ext cx="643689" cy="276999"/>
              <a:chOff x="5772724" y="5215146"/>
              <a:chExt cx="643689" cy="276999"/>
            </a:xfrm>
          </p:grpSpPr>
          <p:cxnSp>
            <p:nvCxnSpPr>
              <p:cNvPr id="37" name="直接连接符 63">
                <a:extLst>
                  <a:ext uri="{FF2B5EF4-FFF2-40B4-BE49-F238E27FC236}">
                    <a16:creationId xmlns:a16="http://schemas.microsoft.com/office/drawing/2014/main" id="{97E46E90-C1F0-777D-37CA-915DF045F0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23527" y="547294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文本框 49">
                <a:extLst>
                  <a:ext uri="{FF2B5EF4-FFF2-40B4-BE49-F238E27FC236}">
                    <a16:creationId xmlns:a16="http://schemas.microsoft.com/office/drawing/2014/main" id="{CD630F80-FDB1-7BF7-E1F9-D50DA99B3736}"/>
                  </a:ext>
                </a:extLst>
              </p:cNvPr>
              <p:cNvSpPr txBox="1"/>
              <p:nvPr/>
            </p:nvSpPr>
            <p:spPr>
              <a:xfrm>
                <a:off x="5772724" y="5215146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6" name="直接连接符 63">
              <a:extLst>
                <a:ext uri="{FF2B5EF4-FFF2-40B4-BE49-F238E27FC236}">
                  <a16:creationId xmlns:a16="http://schemas.microsoft.com/office/drawing/2014/main" id="{76DC278C-452B-5031-0411-AEAABCE2198E}"/>
                </a:ext>
              </a:extLst>
            </p:cNvPr>
            <p:cNvCxnSpPr>
              <a:cxnSpLocks/>
            </p:cNvCxnSpPr>
            <p:nvPr/>
          </p:nvCxnSpPr>
          <p:spPr>
            <a:xfrm>
              <a:off x="6249305" y="3358764"/>
              <a:ext cx="1828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文本框 41">
            <a:extLst>
              <a:ext uri="{FF2B5EF4-FFF2-40B4-BE49-F238E27FC236}">
                <a16:creationId xmlns:a16="http://schemas.microsoft.com/office/drawing/2014/main" id="{95ADEE71-FF57-E706-24E5-29711A1A0DF6}"/>
              </a:ext>
            </a:extLst>
          </p:cNvPr>
          <p:cNvSpPr txBox="1"/>
          <p:nvPr/>
        </p:nvSpPr>
        <p:spPr>
          <a:xfrm>
            <a:off x="11260092" y="296375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D9D329E2-D90A-829C-2DFB-9DE41486B7C1}"/>
              </a:ext>
            </a:extLst>
          </p:cNvPr>
          <p:cNvSpPr txBox="1"/>
          <p:nvPr/>
        </p:nvSpPr>
        <p:spPr>
          <a:xfrm>
            <a:off x="11255802" y="366093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FD6D5C9-DF7B-730C-80C7-311762FED662}"/>
              </a:ext>
            </a:extLst>
          </p:cNvPr>
          <p:cNvSpPr txBox="1"/>
          <p:nvPr/>
        </p:nvSpPr>
        <p:spPr>
          <a:xfrm>
            <a:off x="11255802" y="420659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E7CADE9E-CE07-186B-AC3F-BC82ABCBF82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79" t="38910" r="27431" b="19279"/>
          <a:stretch/>
        </p:blipFill>
        <p:spPr>
          <a:xfrm>
            <a:off x="6988119" y="1675026"/>
            <a:ext cx="4288356" cy="3292626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F324952A-1F36-3311-8BB5-B42481954648}"/>
              </a:ext>
            </a:extLst>
          </p:cNvPr>
          <p:cNvSpPr txBox="1"/>
          <p:nvPr/>
        </p:nvSpPr>
        <p:spPr>
          <a:xfrm>
            <a:off x="11255802" y="235921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8C0B27D-D2FB-C886-F2F3-71C942B36003}"/>
              </a:ext>
            </a:extLst>
          </p:cNvPr>
          <p:cNvSpPr txBox="1"/>
          <p:nvPr/>
        </p:nvSpPr>
        <p:spPr>
          <a:xfrm>
            <a:off x="11253941" y="209963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5C4D7FB-E29E-66BE-CC46-20E873AEE425}"/>
              </a:ext>
            </a:extLst>
          </p:cNvPr>
          <p:cNvSpPr txBox="1"/>
          <p:nvPr/>
        </p:nvSpPr>
        <p:spPr>
          <a:xfrm>
            <a:off x="11255802" y="266804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460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9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2</cp:revision>
  <dcterms:created xsi:type="dcterms:W3CDTF">2023-01-27T03:05:01Z</dcterms:created>
  <dcterms:modified xsi:type="dcterms:W3CDTF">2023-01-27T16:48:05Z</dcterms:modified>
</cp:coreProperties>
</file>